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56" r:id="rId15"/>
    <p:sldId id="270" r:id="rId16"/>
    <p:sldId id="271" r:id="rId17"/>
    <p:sldId id="272" r:id="rId18"/>
    <p:sldId id="273" r:id="rId19"/>
    <p:sldId id="274" r:id="rId20"/>
    <p:sldId id="275" r:id="rId2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10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DD1D6E-C76A-0B7C-9C90-C97753C203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1185CB4-48F4-2D46-DA13-1AFE0D3EB22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C7B3FD-2380-EF41-F68B-88ED7E9545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BEE30-A28F-4D67-9D30-42281B503FC6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697A44-688C-87CB-9A83-35B0CEB2CD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FB533D-F52E-EF83-26C7-C8161ED78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A67DA-25BF-4939-B2B5-56CC69237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971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1F2ABE-E2D4-2ADD-482A-26B1DA255F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2400FA-A003-308F-199A-A9A072AD98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0B2238-2943-DB33-4C07-1A4A156BB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BEE30-A28F-4D67-9D30-42281B503FC6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935706-C208-6DF5-83BF-DA6E0D1653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72F20A-CDC8-720D-305E-423B85D655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A67DA-25BF-4939-B2B5-56CC69237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442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B8772C-70DB-26A6-0A3F-EEBBDFAECF4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5BCB60-0CB7-6F58-83C8-8B6AF0E843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48D97B-214D-AE45-5F42-5E33DBB57B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BEE30-A28F-4D67-9D30-42281B503FC6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48D9F3-AE5D-647C-C545-A85868D19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5C7D1B-3993-1E7E-84DE-EAE2D12155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A67DA-25BF-4939-B2B5-56CC69237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448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7D3223-7171-8240-C98F-118CA10398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C81BBF-DFE9-6FB1-82B3-9FD7161966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EA2867-98D2-AC95-ED6E-70BC2E7499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BEE30-A28F-4D67-9D30-42281B503FC6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2F8B07-0FAD-B4E5-8628-27D4140451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EF2BA1-6659-2FFF-888A-7A9104B5D0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A67DA-25BF-4939-B2B5-56CC69237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76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EB27D6-44FE-C7E3-8B12-24C305C198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04A75C-8E1D-1690-F1F4-9732B8D28E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031FB7-4AF0-306F-D721-5F0F9374B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BEE30-A28F-4D67-9D30-42281B503FC6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82E4F8-9909-E404-6570-22240A73FD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14550D-4416-B30F-483F-7ADADEC124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A67DA-25BF-4939-B2B5-56CC69237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93428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1870E3-A552-4008-9E45-75E8CDC438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02BFFF5-688F-9D60-F984-4198356872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3CFD25F-93A4-D30D-CEBC-5165BE5B65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70FD09-044F-8B1D-2CF0-97D95C5AF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BEE30-A28F-4D67-9D30-42281B503FC6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143E17-4204-EA30-AF77-EB47D5402F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5E6E41-60EE-8858-C75F-00B84B9A38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A67DA-25BF-4939-B2B5-56CC69237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6743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CB1E47-B37F-7A0D-FAA9-A9CAD821B1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36D184-B70F-A79C-FAE9-95D58D1E2F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697567-C0C7-31D8-85E3-87356BA5C6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6FB4417-15A5-9602-9E31-E1AA743657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8298546-1F98-679E-F6EF-70844FAD9FA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F5DE4F8-290B-B06E-194A-3E04B07F18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BEE30-A28F-4D67-9D30-42281B503FC6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35CFBB0-A31B-6FC8-7FC4-1D626D571F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BC416CA-D5D4-8FA4-2647-431BFF0D2C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A67DA-25BF-4939-B2B5-56CC69237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34676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7543A5-17B6-AC51-D8EC-60D15B3BD3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0DD1766-8784-E5FE-7257-FB6AB4DCC8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BEE30-A28F-4D67-9D30-42281B503FC6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2B1D5B6-8DFF-269B-1D44-4484D6C36E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83CF153-800B-B0A7-A6B0-5468E0DDAF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A67DA-25BF-4939-B2B5-56CC69237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3977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726F79A-DFFA-8F6D-560F-BF09F78E58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BEE30-A28F-4D67-9D30-42281B503FC6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B6C2140-39AB-5056-4485-576828294A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20BAD2D-6E77-F241-7E51-D5509FAE44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A67DA-25BF-4939-B2B5-56CC69237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417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719FB3-A8FA-B3ED-75DE-5E0FB1267F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76F425-D9C4-6A51-AEA6-162A854869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CC1119C-83D7-18A0-BBF0-45E6ED7D33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300070-591F-A17E-4133-E6E399AFE0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BEE30-A28F-4D67-9D30-42281B503FC6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75E881-ED99-80F7-FCCE-92FA10A1F0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935569-82A3-BE5A-D714-96303287F6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A67DA-25BF-4939-B2B5-56CC69237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453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A89118-680B-C925-3FF8-C3899A90AC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7A7484B-5ADF-923E-F6A5-05AB6CDDDD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12C295-8BD9-47ED-B274-8C83F23308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2D8CDD-F5A2-B433-4FCE-71671B379E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BEE30-A28F-4D67-9D30-42281B503FC6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646AAE-1D40-63FF-11ED-A04DA4C3FA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3A5D44-6BD9-36EE-5C72-242108B4FB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A67DA-25BF-4939-B2B5-56CC69237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667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BD1E74F-9E82-3FEC-BC83-7202B0A7B5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B6084F-93B3-F4A4-C74A-D9ADAE6B3C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060EC3-7C86-734A-D03D-ED76C6A63CE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D1BEE30-A28F-4D67-9D30-42281B503FC6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3916CC-FBE7-E8DA-4BB2-ACF11C0522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78DFDC-8C85-0CBC-13EC-8BAE5A179E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B5A67DA-25BF-4939-B2B5-56CC69237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87522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BAB644A-0488-F496-36F4-57B87F3A967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770EA984-C67D-E59F-7E72-63E2C48D36A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6864"/>
            <a:ext cx="12192000" cy="5224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75777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E7A4BE4-772A-8087-9A60-636BD26790A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9786CD6B-A0FB-08C5-53D0-E9C27CB3D2C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6864"/>
            <a:ext cx="12192000" cy="5224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309895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8E28B79-0AF0-E7B4-816E-7A76E12FEE0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hart with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7A65B979-37DC-92AF-3F8F-49723233B8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6864"/>
            <a:ext cx="12192000" cy="5224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672063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DB70BE9-5D25-524A-FD96-9FF5D282255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6A008DE8-2782-EBBF-FDA1-1C6C8EC9F5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6864"/>
            <a:ext cx="12192000" cy="5224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376569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F84FD6D-6280-637B-68D5-EDA04927581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with different colored lines&#10;&#10;Description automatically generated">
            <a:extLst>
              <a:ext uri="{FF2B5EF4-FFF2-40B4-BE49-F238E27FC236}">
                <a16:creationId xmlns:a16="http://schemas.microsoft.com/office/drawing/2014/main" id="{C660A082-26FA-8C44-5C16-B6D74303E4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6864"/>
            <a:ext cx="12192000" cy="5224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151826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graph of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F0E4AF5E-9A32-D6D6-9E6D-6ED6946D239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6864"/>
            <a:ext cx="12192000" cy="5224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4346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A57FF12-8B30-F20F-919D-7BA2081BED9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228DEC8D-0934-DDE3-69A4-0C8CEA4E365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6864"/>
            <a:ext cx="12192000" cy="5224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168360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4E94518-FD6B-DC76-05CD-25F49ED20D5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a number of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04232166-64F6-3560-7D59-566EC1EF4A8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6864"/>
            <a:ext cx="12192000" cy="5224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596352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CAE201E-44C7-EF5C-163E-FBD453469FA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a number of data&#10;&#10;Description automatically generated with medium confidence">
            <a:extLst>
              <a:ext uri="{FF2B5EF4-FFF2-40B4-BE49-F238E27FC236}">
                <a16:creationId xmlns:a16="http://schemas.microsoft.com/office/drawing/2014/main" id="{FC18407C-F02D-B2D9-B7C0-0E442749D0C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6864"/>
            <a:ext cx="12192000" cy="5224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441874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528FBDB-B911-D256-F9B4-FBEA0CD32BD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different colored lines&#10;&#10;Description automatically generated">
            <a:extLst>
              <a:ext uri="{FF2B5EF4-FFF2-40B4-BE49-F238E27FC236}">
                <a16:creationId xmlns:a16="http://schemas.microsoft.com/office/drawing/2014/main" id="{E507898D-2EFA-C5F9-8BF2-30A498D93D4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6864"/>
            <a:ext cx="12192000" cy="5224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818074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729CBB8-57CF-A669-C9FA-2A0911E0910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with different colored lines&#10;&#10;Description automatically generated">
            <a:extLst>
              <a:ext uri="{FF2B5EF4-FFF2-40B4-BE49-F238E27FC236}">
                <a16:creationId xmlns:a16="http://schemas.microsoft.com/office/drawing/2014/main" id="{134518F2-AB44-0620-6E2D-48C02C2649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6864"/>
            <a:ext cx="12192000" cy="5224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44464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AE8ACF2-6A71-95BE-FC38-1D88E6EDE93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a number of data&#10;&#10;Description automatically generated with medium confidence">
            <a:extLst>
              <a:ext uri="{FF2B5EF4-FFF2-40B4-BE49-F238E27FC236}">
                <a16:creationId xmlns:a16="http://schemas.microsoft.com/office/drawing/2014/main" id="{D230B592-3FDA-E0E5-402C-220ADBD998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6864"/>
            <a:ext cx="12192000" cy="5224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4259630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EF467DB-D7DD-D0EE-9A27-8A47F9F341F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4B0B534E-F915-EFD3-F52E-A6E6103D840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6864"/>
            <a:ext cx="12192000" cy="5224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35517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FC7725F-ED86-8011-C65F-F03D4AE4311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E4447694-68C8-AB1D-6BA0-EEEE0757FD5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6864"/>
            <a:ext cx="12192000" cy="5224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57883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1941BF5-52C7-87AA-BE41-F7E89DD1071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with different colored lines&#10;&#10;Description automatically generated">
            <a:extLst>
              <a:ext uri="{FF2B5EF4-FFF2-40B4-BE49-F238E27FC236}">
                <a16:creationId xmlns:a16="http://schemas.microsoft.com/office/drawing/2014/main" id="{D9BBB4BE-00DB-B1BC-BAF6-3B5D44EA1B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5340"/>
            <a:ext cx="12192000" cy="52273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62177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3B4DC16-F275-4C51-A650-850D8F9D650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84A12CFC-3616-5FAD-46CA-97B654CEB2E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6864"/>
            <a:ext cx="12192000" cy="5224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15462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8941C75-DDEE-8FB8-C7F2-9D12A8CB458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9D8BCA57-202A-47C3-E209-98AF6C05A88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6864"/>
            <a:ext cx="12192000" cy="5224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99075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93DE878-6D07-0ACA-6BEC-53FA390FEC5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with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20323FC0-1D14-08E6-F883-03DA8B1E22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6864"/>
            <a:ext cx="12192000" cy="5224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354450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D69335B-C850-62CF-2D92-06E0669034F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A9B5F384-243C-5465-F864-5AAE8266391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6864"/>
            <a:ext cx="12192000" cy="5224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899092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7B87947-65DC-3F54-49D4-9C829B449A7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BF2A0B4C-C790-C7C5-445A-3310F62976B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6864"/>
            <a:ext cx="12192000" cy="5224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9287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03</TotalTime>
  <Words>0</Words>
  <Application>Microsoft Office PowerPoint</Application>
  <PresentationFormat>Widescreen</PresentationFormat>
  <Paragraphs>0</Paragraphs>
  <Slides>2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4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atrick Bewick</dc:creator>
  <cp:lastModifiedBy>Colla'kova', Eva</cp:lastModifiedBy>
  <cp:revision>6</cp:revision>
  <dcterms:created xsi:type="dcterms:W3CDTF">2025-01-23T20:59:29Z</dcterms:created>
  <dcterms:modified xsi:type="dcterms:W3CDTF">2025-02-06T21:32:41Z</dcterms:modified>
</cp:coreProperties>
</file>